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61" r:id="rId3"/>
    <p:sldId id="263" r:id="rId4"/>
    <p:sldId id="262" r:id="rId5"/>
    <p:sldId id="264" r:id="rId6"/>
    <p:sldId id="265" r:id="rId7"/>
  </p:sldIdLst>
  <p:sldSz cx="27432000" cy="2286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24" autoAdjust="0"/>
    <p:restoredTop sz="94660"/>
  </p:normalViewPr>
  <p:slideViewPr>
    <p:cSldViewPr snapToGrid="0">
      <p:cViewPr varScale="1">
        <p:scale>
          <a:sx n="31" d="100"/>
          <a:sy n="31" d="100"/>
        </p:scale>
        <p:origin x="392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741210"/>
            <a:ext cx="23317200" cy="79586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2006793"/>
            <a:ext cx="20574000" cy="5519207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935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414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217084"/>
            <a:ext cx="5915025" cy="1937279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217084"/>
            <a:ext cx="17402175" cy="1937279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6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860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699132"/>
            <a:ext cx="23660100" cy="9509123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5298215"/>
            <a:ext cx="23660100" cy="5000623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793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6085417"/>
            <a:ext cx="11658600" cy="145044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6085417"/>
            <a:ext cx="11658600" cy="145044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716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217089"/>
            <a:ext cx="23660100" cy="44185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603877"/>
            <a:ext cx="11605020" cy="2746373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8350250"/>
            <a:ext cx="11605020" cy="122819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603877"/>
            <a:ext cx="11662173" cy="2746373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8350250"/>
            <a:ext cx="11662173" cy="122819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526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747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582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524000"/>
            <a:ext cx="8847534" cy="5334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3291422"/>
            <a:ext cx="13887450" cy="1624541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858000"/>
            <a:ext cx="8847534" cy="12705293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80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524000"/>
            <a:ext cx="8847534" cy="5334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3291422"/>
            <a:ext cx="13887450" cy="1624541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858000"/>
            <a:ext cx="8847534" cy="12705293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024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217089"/>
            <a:ext cx="23660100" cy="44185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6085417"/>
            <a:ext cx="23660100" cy="145044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21187839"/>
            <a:ext cx="61722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330D9-E320-4EAE-B881-10610BD95491}" type="datetimeFigureOut">
              <a:rPr lang="en-US" smtClean="0"/>
              <a:t>6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21187839"/>
            <a:ext cx="92583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21187839"/>
            <a:ext cx="61722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07201-E79A-40D4-8783-3657AAC7BC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59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0"/>
            <a:ext cx="27432000" cy="1219199"/>
          </a:xfrm>
        </p:spPr>
        <p:txBody>
          <a:bodyPr>
            <a:normAutofit/>
          </a:bodyPr>
          <a:lstStyle/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3656" r="5493" b="31153"/>
          <a:stretch/>
        </p:blipFill>
        <p:spPr>
          <a:xfrm>
            <a:off x="560439" y="1219199"/>
            <a:ext cx="25898168" cy="216277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0439" y="1515068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60439" y="7242358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676968" y="7242358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238839" y="7242358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60439" y="15208215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676968" y="15208215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238839" y="15208215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513291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0"/>
            <a:ext cx="27432000" cy="1219199"/>
          </a:xfrm>
        </p:spPr>
        <p:txBody>
          <a:bodyPr>
            <a:normAutofit/>
          </a:bodyPr>
          <a:lstStyle/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1111" r="15205" b="15349"/>
          <a:stretch/>
        </p:blipFill>
        <p:spPr>
          <a:xfrm>
            <a:off x="5486400" y="1219199"/>
            <a:ext cx="16459200" cy="2158778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50426" y="1219199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3716000" y="1219199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50426" y="12013093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716000" y="12013093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78807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l="2927" t="3054" r="1984" b="3249"/>
          <a:stretch/>
        </p:blipFill>
        <p:spPr>
          <a:xfrm>
            <a:off x="3352334" y="1483976"/>
            <a:ext cx="20727332" cy="21376024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0"/>
            <a:ext cx="27432000" cy="1219199"/>
          </a:xfrm>
        </p:spPr>
        <p:txBody>
          <a:bodyPr>
            <a:normAutofit/>
          </a:bodyPr>
          <a:lstStyle/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173956" y="1192692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3626811" y="1192692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73956" y="12026346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626811" y="12026346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590367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0"/>
            <a:ext cx="27432000" cy="1219199"/>
          </a:xfrm>
        </p:spPr>
        <p:txBody>
          <a:bodyPr>
            <a:normAutofit/>
          </a:bodyPr>
          <a:lstStyle/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1725" y="3263261"/>
            <a:ext cx="20128549" cy="15564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8013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0" y="0"/>
            <a:ext cx="27432000" cy="1219199"/>
          </a:xfrm>
        </p:spPr>
        <p:txBody>
          <a:bodyPr>
            <a:normAutofit/>
          </a:bodyPr>
          <a:lstStyle/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r="1495" b="20522"/>
          <a:stretch/>
        </p:blipFill>
        <p:spPr>
          <a:xfrm>
            <a:off x="0" y="3179137"/>
            <a:ext cx="27432000" cy="161483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3179137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642555" y="3179137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037277" y="3179137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22955" y="11472647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001135" y="11472647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9634780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C62907BF-C3E5-E448-A845-B56FFC087C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3220" y="374076"/>
            <a:ext cx="18385560" cy="22512930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E49BB283-6C2F-5C46-8425-1C7A39DD7EFA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27432000" cy="121919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27432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132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6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4B4440-22DD-A943-B4A5-409981496D69}"/>
              </a:ext>
            </a:extLst>
          </p:cNvPr>
          <p:cNvSpPr txBox="1"/>
          <p:nvPr/>
        </p:nvSpPr>
        <p:spPr>
          <a:xfrm>
            <a:off x="4647912" y="757534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F551A0-8883-BF4E-8662-40C3C0296006}"/>
              </a:ext>
            </a:extLst>
          </p:cNvPr>
          <p:cNvSpPr txBox="1"/>
          <p:nvPr/>
        </p:nvSpPr>
        <p:spPr>
          <a:xfrm>
            <a:off x="4647912" y="11822270"/>
            <a:ext cx="98473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US" sz="5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52802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</TotalTime>
  <Words>40</Words>
  <Application>Microsoft Macintosh PowerPoint</Application>
  <PresentationFormat>Custom</PresentationFormat>
  <Paragraphs>2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l Figure 1 </vt:lpstr>
      <vt:lpstr>Supplemental Figure 2</vt:lpstr>
      <vt:lpstr>Supplemental Figure 3</vt:lpstr>
      <vt:lpstr>Supplemental Figure 4</vt:lpstr>
      <vt:lpstr>Supplemental Figure 5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Luhan Tracy Zhou</dc:creator>
  <cp:lastModifiedBy>Hunter Bradley Rogers</cp:lastModifiedBy>
  <cp:revision>27</cp:revision>
  <dcterms:created xsi:type="dcterms:W3CDTF">2020-05-08T19:42:37Z</dcterms:created>
  <dcterms:modified xsi:type="dcterms:W3CDTF">2020-06-20T22:18:50Z</dcterms:modified>
</cp:coreProperties>
</file>